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72" r:id="rId1"/>
  </p:sldMasterIdLst>
  <p:sldIdLst>
    <p:sldId id="256" r:id="rId2"/>
    <p:sldId id="257" r:id="rId3"/>
  </p:sldIdLst>
  <p:sldSz cx="6858000" cy="9144000" type="screen4x3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35" autoAdjust="0"/>
    <p:restoredTop sz="94660"/>
  </p:normalViewPr>
  <p:slideViewPr>
    <p:cSldViewPr snapToGrid="0">
      <p:cViewPr varScale="1">
        <p:scale>
          <a:sx n="39" d="100"/>
          <a:sy n="39" d="100"/>
        </p:scale>
        <p:origin x="1326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7400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2677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139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8923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9725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9136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5301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276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6047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4569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7530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9B06A4-ACFD-4F7B-8C14-B5BC8289D921}" type="datetimeFigureOut">
              <a:rPr kumimoji="1" lang="ja-JP" altLang="en-US" smtClean="0"/>
              <a:t>2026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233EE2-2BA8-44CC-B3C3-57EF2D9B0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231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黒いバックグラウンドの前に立っている&#10;&#10;低い精度で自動的に生成された説明">
            <a:extLst>
              <a:ext uri="{FF2B5EF4-FFF2-40B4-BE49-F238E27FC236}">
                <a16:creationId xmlns:a16="http://schemas.microsoft.com/office/drawing/2014/main" id="{B50FC37F-8D76-8F2D-C021-8727218BB6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143" y="490818"/>
            <a:ext cx="3474672" cy="8404412"/>
          </a:xfrm>
          <a:prstGeom prst="rect">
            <a:avLst/>
          </a:prstGeom>
        </p:spPr>
      </p:pic>
      <p:sp>
        <p:nvSpPr>
          <p:cNvPr id="6" name="四角形: 角を丸くする 5">
            <a:extLst>
              <a:ext uri="{FF2B5EF4-FFF2-40B4-BE49-F238E27FC236}">
                <a16:creationId xmlns:a16="http://schemas.microsoft.com/office/drawing/2014/main" id="{C7EA4490-23E9-B9B8-3DFD-9A514D7E8F1C}"/>
              </a:ext>
            </a:extLst>
          </p:cNvPr>
          <p:cNvSpPr/>
          <p:nvPr/>
        </p:nvSpPr>
        <p:spPr>
          <a:xfrm>
            <a:off x="557143" y="490818"/>
            <a:ext cx="922033" cy="1418664"/>
          </a:xfrm>
          <a:prstGeom prst="roundRect">
            <a:avLst>
              <a:gd name="adj" fmla="val 6458"/>
            </a:avLst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四角形: 角を丸くする 6">
            <a:extLst>
              <a:ext uri="{FF2B5EF4-FFF2-40B4-BE49-F238E27FC236}">
                <a16:creationId xmlns:a16="http://schemas.microsoft.com/office/drawing/2014/main" id="{4755AC1A-A4CA-77F3-7FA3-CB8BEC65514C}"/>
              </a:ext>
            </a:extLst>
          </p:cNvPr>
          <p:cNvSpPr/>
          <p:nvPr/>
        </p:nvSpPr>
        <p:spPr>
          <a:xfrm>
            <a:off x="2272554" y="1788229"/>
            <a:ext cx="1134823" cy="6522501"/>
          </a:xfrm>
          <a:prstGeom prst="roundRect">
            <a:avLst>
              <a:gd name="adj" fmla="val 7365"/>
            </a:avLst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C4B426C-A24E-73CA-CE6B-FD276B6103F8}"/>
              </a:ext>
            </a:extLst>
          </p:cNvPr>
          <p:cNvSpPr txBox="1"/>
          <p:nvPr/>
        </p:nvSpPr>
        <p:spPr>
          <a:xfrm>
            <a:off x="1471059" y="490818"/>
            <a:ext cx="1282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inor </a:t>
            </a:r>
            <a:r>
              <a:rPr kumimoji="1" lang="en-US" altLang="ja-JP" i="1" dirty="0" err="1"/>
              <a:t>ipaH</a:t>
            </a:r>
            <a:endParaRPr kumimoji="1" lang="ja-JP" altLang="en-US" i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B9786C2-3CCA-1FAE-28E1-D848A9C936F2}"/>
              </a:ext>
            </a:extLst>
          </p:cNvPr>
          <p:cNvSpPr txBox="1"/>
          <p:nvPr/>
        </p:nvSpPr>
        <p:spPr>
          <a:xfrm>
            <a:off x="3407377" y="1788229"/>
            <a:ext cx="12795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ajor </a:t>
            </a:r>
            <a:r>
              <a:rPr kumimoji="1" lang="en-US" altLang="ja-JP" i="1" dirty="0" err="1"/>
              <a:t>ipaH</a:t>
            </a:r>
            <a:endParaRPr kumimoji="1" lang="ja-JP" altLang="en-US" i="1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0C69779-E25F-75A3-B559-A08387FE2BA4}"/>
              </a:ext>
            </a:extLst>
          </p:cNvPr>
          <p:cNvSpPr txBox="1"/>
          <p:nvPr/>
        </p:nvSpPr>
        <p:spPr>
          <a:xfrm>
            <a:off x="4672467" y="306152"/>
            <a:ext cx="11398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1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147600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24C5F542-2E2D-48CD-8FCB-7B60047FAAD6}"/>
              </a:ext>
            </a:extLst>
          </p:cNvPr>
          <p:cNvGrpSpPr/>
          <p:nvPr/>
        </p:nvGrpSpPr>
        <p:grpSpPr>
          <a:xfrm>
            <a:off x="437030" y="524157"/>
            <a:ext cx="5983940" cy="4154984"/>
            <a:chOff x="437030" y="524157"/>
            <a:chExt cx="5983940" cy="4154984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E935CE09-34C0-AAB0-D4B2-BA6A3D21ABEC}"/>
                </a:ext>
              </a:extLst>
            </p:cNvPr>
            <p:cNvSpPr txBox="1"/>
            <p:nvPr/>
          </p:nvSpPr>
          <p:spPr>
            <a:xfrm>
              <a:off x="437030" y="524157"/>
              <a:ext cx="5983940" cy="41549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FIG S1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200" dirty="0"/>
                <a:t>Design of primers and probes for </a:t>
              </a:r>
              <a:r>
                <a:rPr lang="en-US" altLang="ja-JP" sz="1200" i="1" dirty="0" err="1"/>
                <a:t>ipaH</a:t>
              </a:r>
              <a:r>
                <a:rPr lang="en-US" altLang="ja-JP" sz="1200" dirty="0"/>
                <a:t> detection by real-time PCR</a:t>
              </a:r>
              <a:endParaRPr lang="ja-JP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  <a:p>
              <a:endPara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  <a:p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The coding genes with the annotation of “</a:t>
              </a:r>
              <a:r>
                <a:rPr lang="en-US" altLang="ja-JP" sz="1200" i="1" kern="100" dirty="0" err="1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i="1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“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were extracted from complete genome sequences of 98 strains of </a:t>
              </a:r>
              <a:r>
                <a:rPr lang="en-US" altLang="ja-JP" sz="1200" i="1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Shigella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species and 8 sequences of the </a:t>
              </a:r>
              <a:r>
                <a:rPr lang="en-US" altLang="ja-JP" sz="1200" i="1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Shigella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-derived plasmids. Phylogenetic tree was constructed using </a:t>
              </a:r>
              <a:r>
                <a:rPr lang="en-US" altLang="ja-JP" sz="1200" kern="100" dirty="0" err="1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mafft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(version 7.505) and </a:t>
              </a:r>
              <a:r>
                <a:rPr lang="en-US" altLang="ja-JP" sz="1200" kern="100" dirty="0" err="1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q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-tree (version 2.1.4 beta). The trees were visualized using </a:t>
              </a:r>
              <a:r>
                <a:rPr lang="en-US" altLang="ja-JP" sz="1200" kern="100" dirty="0" err="1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FigTree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(version 1.4.4). Thus, the sequences were divided as follows: major </a:t>
              </a:r>
              <a:r>
                <a:rPr lang="en-US" altLang="ja-JP" sz="1200" i="1" kern="100" dirty="0" err="1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, 100 sequences with gene length range of 1,400–2,982 bps; minor </a:t>
              </a:r>
              <a:r>
                <a:rPr lang="en-US" altLang="ja-JP" sz="1200" i="1" kern="100" dirty="0" err="1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, 20 sequences with gene lengths of 480 and 505 bps; and 4 other sequences. The major </a:t>
              </a:r>
              <a:r>
                <a:rPr lang="en-US" altLang="ja-JP" sz="1200" i="1" kern="100" dirty="0" err="1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cluster contains all functional </a:t>
              </a:r>
              <a:r>
                <a:rPr lang="en-US" altLang="ja-JP" sz="1200" i="1" kern="100" dirty="0" err="1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sequences</a:t>
              </a:r>
              <a:r>
                <a:rPr lang="ja-JP" altLang="en-US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(1,</a:t>
              </a:r>
              <a:r>
                <a:rPr lang="ja-JP" altLang="en-US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2), whereas the minor </a:t>
              </a:r>
              <a:r>
                <a:rPr lang="en-US" altLang="ja-JP" sz="1200" i="1" kern="100" dirty="0" err="1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cluster, although exhibiting high homology, remains uncertain regarding any functional significances. Furthermore, the remaining four sequences were considered to be pseudogenes. 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Therefore, primers and probes were designed to detect </a:t>
              </a:r>
              <a:r>
                <a:rPr lang="en-US" altLang="ja-JP" sz="1200" i="1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targeting the 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m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ajor </a:t>
              </a:r>
              <a:r>
                <a:rPr lang="en-US" altLang="ja-JP" sz="1200" i="1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cluster.</a:t>
              </a:r>
            </a:p>
            <a:p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White circles,    : plasmid-borne </a:t>
              </a:r>
              <a:r>
                <a:rPr lang="en-US" altLang="ja-JP" sz="1200" i="1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, black circles,     : chromosomal </a:t>
              </a:r>
              <a:r>
                <a:rPr lang="en-US" altLang="ja-JP" sz="1200" i="1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.</a:t>
              </a:r>
            </a:p>
            <a:p>
              <a:endPara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  <a:p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References: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US" altLang="ja-JP" sz="1200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Ashida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, H., </a:t>
              </a:r>
              <a:r>
                <a:rPr lang="en-US" altLang="ja-JP" sz="1200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Toyotome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, T., Nagai, T., and </a:t>
              </a:r>
              <a:r>
                <a:rPr lang="en-US" altLang="ja-JP" sz="1200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Sasakawa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, C. 2007. </a:t>
              </a:r>
              <a:r>
                <a:rPr lang="en-US" altLang="ja-JP" sz="1200" i="1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Shigella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chromosomal </a:t>
              </a:r>
              <a:r>
                <a:rPr lang="en-US" altLang="ja-JP" sz="1200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proteins are secreted via the type III secretion system and act as effectors. </a:t>
              </a:r>
              <a:r>
                <a:rPr lang="pt-BR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Molecular microbiology, </a:t>
              </a:r>
              <a:r>
                <a:rPr lang="pt-BR" altLang="ja-JP" sz="1200" b="1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63</a:t>
              </a:r>
              <a:r>
                <a:rPr lang="pt-BR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:680-693. 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altLang="ja-JP" sz="1200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Ashida</a:t>
              </a:r>
              <a:r>
                <a:rPr lang="en-GB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, H. and </a:t>
              </a:r>
              <a:r>
                <a:rPr lang="en-GB" altLang="ja-JP" sz="1200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Sasakawa</a:t>
              </a:r>
              <a:r>
                <a:rPr lang="en-GB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, C. 2016. </a:t>
              </a:r>
              <a:r>
                <a:rPr lang="en-US" altLang="ja-JP" sz="1200" i="1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Shigella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200" kern="100" dirty="0" err="1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IpaH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family effectors as a versatile model for studying pathogenic bacteria. Frontiers in cellular and infection microbiology, </a:t>
              </a:r>
              <a:r>
                <a:rPr lang="en-US" altLang="ja-JP" sz="1200" b="1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5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:</a:t>
              </a:r>
              <a:r>
                <a:rPr lang="ja-JP" altLang="en-US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 </a:t>
              </a:r>
              <a:r>
                <a:rPr lang="en-US" altLang="ja-JP" sz="1200" kern="100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Article </a:t>
              </a:r>
              <a:r>
                <a:rPr lang="en-US" altLang="ja-JP" sz="12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100.  </a:t>
              </a:r>
              <a:endParaRPr lang="ja-JP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4" name="楕円 3">
              <a:extLst>
                <a:ext uri="{FF2B5EF4-FFF2-40B4-BE49-F238E27FC236}">
                  <a16:creationId xmlns:a16="http://schemas.microsoft.com/office/drawing/2014/main" id="{DE75DB15-EB98-FEC9-DB2F-88265D48FFB1}"/>
                </a:ext>
              </a:extLst>
            </p:cNvPr>
            <p:cNvSpPr/>
            <p:nvPr/>
          </p:nvSpPr>
          <p:spPr>
            <a:xfrm flipH="1">
              <a:off x="4006514" y="2995866"/>
              <a:ext cx="120316" cy="12031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5" name="楕円 4">
              <a:extLst>
                <a:ext uri="{FF2B5EF4-FFF2-40B4-BE49-F238E27FC236}">
                  <a16:creationId xmlns:a16="http://schemas.microsoft.com/office/drawing/2014/main" id="{B216BC42-36A8-1CBC-725C-7D8968626A21}"/>
                </a:ext>
              </a:extLst>
            </p:cNvPr>
            <p:cNvSpPr/>
            <p:nvPr/>
          </p:nvSpPr>
          <p:spPr>
            <a:xfrm flipH="1">
              <a:off x="1451810" y="2983832"/>
              <a:ext cx="120316" cy="12031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34396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0</Words>
  <Application>Microsoft Office PowerPoint</Application>
  <PresentationFormat>画面に合わせる (4:3)</PresentationFormat>
  <Paragraphs>1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6-05-20T13:39:30Z</dcterms:created>
  <dcterms:modified xsi:type="dcterms:W3CDTF">2026-05-20T13:40:14Z</dcterms:modified>
</cp:coreProperties>
</file>